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67" r:id="rId3"/>
  </p:sldIdLst>
  <p:sldSz cx="6858000" cy="12192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605" autoAdjust="0"/>
    <p:restoredTop sz="94660"/>
  </p:normalViewPr>
  <p:slideViewPr>
    <p:cSldViewPr snapToGrid="0">
      <p:cViewPr>
        <p:scale>
          <a:sx n="66" d="100"/>
          <a:sy n="66" d="100"/>
        </p:scale>
        <p:origin x="1980" y="-1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3414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2651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96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946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9385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3728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1973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4536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8558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8618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5205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082723-5B87-402A-8C54-A6DC0C7FF27E}" type="datetimeFigureOut">
              <a:rPr lang="zh-CN" altLang="en-US" smtClean="0"/>
              <a:t>2026/4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6C6B3A-23D9-41BF-9143-CF101097B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7417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779965" y="1201914"/>
            <a:ext cx="180558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FITC-MOTS-c (Repeat 1-3)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17426" y="3056584"/>
            <a:ext cx="255370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FITC-R13A-MOTS-c (Repeat 1-3)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45625" y="4897715"/>
            <a:ext cx="2878556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LAT1-siRNA+FITC-MOTS-c (Repeat 1-3)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712" y="1433419"/>
            <a:ext cx="1627902" cy="162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203" y="1450123"/>
            <a:ext cx="1627902" cy="162000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694" y="1450123"/>
            <a:ext cx="1627902" cy="1620000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1516587" y="2900591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381626" y="2915376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5216441" y="2919546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712" y="3291254"/>
            <a:ext cx="1627902" cy="162000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0073" y="3291254"/>
            <a:ext cx="1627902" cy="1620000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0081" y="3291254"/>
            <a:ext cx="1627902" cy="162000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1517642" y="4753081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353136" y="4759400"/>
            <a:ext cx="3188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177702" y="4763570"/>
            <a:ext cx="3332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712" y="5185967"/>
            <a:ext cx="1627902" cy="162000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203" y="5185967"/>
            <a:ext cx="1627902" cy="162000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0081" y="5187936"/>
            <a:ext cx="1627902" cy="1620000"/>
          </a:xfrm>
          <a:prstGeom prst="rect">
            <a:avLst/>
          </a:prstGeom>
        </p:spPr>
      </p:pic>
      <p:sp>
        <p:nvSpPr>
          <p:cNvPr id="49" name="文本框 48"/>
          <p:cNvSpPr txBox="1"/>
          <p:nvPr/>
        </p:nvSpPr>
        <p:spPr>
          <a:xfrm>
            <a:off x="722866" y="6897177"/>
            <a:ext cx="2878556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LAT1-siRNA+FITC-R13A-MOTS-c (Repeat 1-3)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1432660" y="6805225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261804" y="6808369"/>
            <a:ext cx="3188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5092720" y="6812539"/>
            <a:ext cx="3332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图片 5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057" y="7171890"/>
            <a:ext cx="1627902" cy="1620000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5548" y="7171890"/>
            <a:ext cx="1627902" cy="1620000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7426" y="7177855"/>
            <a:ext cx="1627902" cy="1620000"/>
          </a:xfrm>
          <a:prstGeom prst="rect">
            <a:avLst/>
          </a:prstGeom>
        </p:spPr>
      </p:pic>
      <p:sp>
        <p:nvSpPr>
          <p:cNvPr id="56" name="文本框 55"/>
          <p:cNvSpPr txBox="1"/>
          <p:nvPr/>
        </p:nvSpPr>
        <p:spPr>
          <a:xfrm>
            <a:off x="1412543" y="8644206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3241687" y="8647350"/>
            <a:ext cx="3188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5072603" y="8651520"/>
            <a:ext cx="3332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166"/>
          <p:cNvSpPr txBox="1"/>
          <p:nvPr/>
        </p:nvSpPr>
        <p:spPr>
          <a:xfrm>
            <a:off x="679908" y="8810376"/>
            <a:ext cx="244892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Leucine+FITC-MOTS-c (Repeat 1-3)</a:t>
            </a:r>
          </a:p>
        </p:txBody>
      </p:sp>
      <p:pic>
        <p:nvPicPr>
          <p:cNvPr id="60" name="图片 59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293" y="9103575"/>
            <a:ext cx="1627902" cy="1620000"/>
          </a:xfrm>
          <a:prstGeom prst="rect">
            <a:avLst/>
          </a:prstGeom>
        </p:spPr>
      </p:pic>
      <p:pic>
        <p:nvPicPr>
          <p:cNvPr id="61" name="图片 60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5548" y="9103575"/>
            <a:ext cx="1627902" cy="1620000"/>
          </a:xfrm>
          <a:prstGeom prst="rect">
            <a:avLst/>
          </a:prstGeom>
        </p:spPr>
      </p:pic>
      <p:pic>
        <p:nvPicPr>
          <p:cNvPr id="62" name="图片 61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7536" y="9103575"/>
            <a:ext cx="1627902" cy="1620000"/>
          </a:xfrm>
          <a:prstGeom prst="rect">
            <a:avLst/>
          </a:prstGeom>
        </p:spPr>
      </p:pic>
      <p:sp>
        <p:nvSpPr>
          <p:cNvPr id="63" name="文本框 62"/>
          <p:cNvSpPr txBox="1"/>
          <p:nvPr/>
        </p:nvSpPr>
        <p:spPr>
          <a:xfrm>
            <a:off x="1402383" y="10580407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3231527" y="10583551"/>
            <a:ext cx="3188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5072603" y="10587721"/>
            <a:ext cx="3332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9542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166"/>
          <p:cNvSpPr txBox="1"/>
          <p:nvPr/>
        </p:nvSpPr>
        <p:spPr>
          <a:xfrm>
            <a:off x="669291" y="441948"/>
            <a:ext cx="2696540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Leucine+FITC-R13A-MOTS-c (Repeat 1-3)</a:t>
            </a:r>
          </a:p>
          <a:p>
            <a:pPr algn="ctr"/>
            <a:endParaRPr lang="en-US" altLang="zh-CN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66"/>
          <p:cNvSpPr txBox="1"/>
          <p:nvPr/>
        </p:nvSpPr>
        <p:spPr>
          <a:xfrm>
            <a:off x="670617" y="2272175"/>
            <a:ext cx="2180836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BCH+FITC-MOTS-c (Repeat 1-3) </a:t>
            </a:r>
          </a:p>
        </p:txBody>
      </p:sp>
      <p:sp>
        <p:nvSpPr>
          <p:cNvPr id="17" name="文本框 166"/>
          <p:cNvSpPr txBox="1"/>
          <p:nvPr/>
        </p:nvSpPr>
        <p:spPr>
          <a:xfrm>
            <a:off x="669291" y="4237659"/>
            <a:ext cx="246326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BCH+FITC-R13A-MOTS-c (Repeat 1-3)</a:t>
            </a: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288" y="699889"/>
            <a:ext cx="1627902" cy="1620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9420" y="699889"/>
            <a:ext cx="1627902" cy="162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0552" y="699889"/>
            <a:ext cx="1627902" cy="1620000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1243964" y="4019804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102739" y="4022948"/>
            <a:ext cx="3188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933655" y="4027118"/>
            <a:ext cx="3332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288" y="2561299"/>
            <a:ext cx="1627902" cy="162000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9420" y="2561299"/>
            <a:ext cx="1627902" cy="1620000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0552" y="2561299"/>
            <a:ext cx="1627902" cy="162000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1264284" y="2168080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123059" y="2171224"/>
            <a:ext cx="3188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953975" y="2175394"/>
            <a:ext cx="3332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034" y="4478086"/>
            <a:ext cx="1627902" cy="162000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8195" y="4478086"/>
            <a:ext cx="1627902" cy="162000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8356" y="4478086"/>
            <a:ext cx="1627902" cy="1620000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1239038" y="5950205"/>
            <a:ext cx="25540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3097813" y="5953349"/>
            <a:ext cx="31881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928729" y="5957519"/>
            <a:ext cx="33329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43495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0</TotalTime>
  <Words>64</Words>
  <Application>Microsoft Office PowerPoint</Application>
  <PresentationFormat>宽屏</PresentationFormat>
  <Paragraphs>3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龙龙 葛</dc:creator>
  <cp:lastModifiedBy>lenovo</cp:lastModifiedBy>
  <cp:revision>21</cp:revision>
  <dcterms:created xsi:type="dcterms:W3CDTF">2026-03-04T09:19:14Z</dcterms:created>
  <dcterms:modified xsi:type="dcterms:W3CDTF">2026-04-03T11:52:20Z</dcterms:modified>
</cp:coreProperties>
</file>